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66" autoAdjust="0"/>
    <p:restoredTop sz="93945"/>
  </p:normalViewPr>
  <p:slideViewPr>
    <p:cSldViewPr snapToGrid="0" snapToObjects="1">
      <p:cViewPr varScale="1">
        <p:scale>
          <a:sx n="49" d="100"/>
          <a:sy n="49" d="100"/>
        </p:scale>
        <p:origin x="1750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14">
            <a:extLst>
              <a:ext uri="{FF2B5EF4-FFF2-40B4-BE49-F238E27FC236}">
                <a16:creationId xmlns:a16="http://schemas.microsoft.com/office/drawing/2014/main" id="{2FFA30B7-4041-CE41-A1EF-1146FBD7DBD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 bwMode="auto">
          <a:xfrm>
            <a:off x="304800" y="323532"/>
            <a:ext cx="5207635" cy="4138295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B557B4B7-373A-4D9A-9F82-829399CA5759}"/>
              </a:ext>
            </a:extLst>
          </p:cNvPr>
          <p:cNvSpPr/>
          <p:nvPr/>
        </p:nvSpPr>
        <p:spPr>
          <a:xfrm>
            <a:off x="242277" y="4507396"/>
            <a:ext cx="527015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: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raken counts from reduced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ta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ntigs for brain (140C), muscle (140M, 159M) or gut (144I) samples. Only the most significant values and honey bee viruses are shown.</a:t>
            </a:r>
            <a:endParaRPr lang="fr-FR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01789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9</TotalTime>
  <Words>39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33</cp:revision>
  <dcterms:created xsi:type="dcterms:W3CDTF">2019-01-23T12:04:28Z</dcterms:created>
  <dcterms:modified xsi:type="dcterms:W3CDTF">2019-07-19T15:52:03Z</dcterms:modified>
</cp:coreProperties>
</file>